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928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6772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9384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805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046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098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7363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445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9580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091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8605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C3A4DA-5B9A-4A36-80CA-AEF70F22827B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88A431-4309-4B39-9B13-9517FBAE11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157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80469" y="167424"/>
            <a:ext cx="11973059" cy="978555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J-tree &amp; PCA between 271 </a:t>
            </a:r>
            <a:r>
              <a:rPr lang="en-US" sz="3200" i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pomoea batatas </a:t>
            </a:r>
            <a:r>
              <a:rPr lang="en-GB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ccessions </a:t>
            </a:r>
            <a:r>
              <a:rPr lang="en-US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mputed with 7,591  polymorphic  SNPs based on biological status</a:t>
            </a:r>
            <a:endParaRPr lang="en-GB" sz="3200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6342204" y="1533378"/>
            <a:ext cx="5711324" cy="5099242"/>
            <a:chOff x="6342204" y="1533378"/>
            <a:chExt cx="5711324" cy="5099242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13679" y="1674253"/>
              <a:ext cx="5639849" cy="4958367"/>
            </a:xfrm>
            <a:prstGeom prst="rect">
              <a:avLst/>
            </a:prstGeom>
          </p:spPr>
        </p:pic>
        <p:grpSp>
          <p:nvGrpSpPr>
            <p:cNvPr id="7" name="Group 6"/>
            <p:cNvGrpSpPr/>
            <p:nvPr/>
          </p:nvGrpSpPr>
          <p:grpSpPr>
            <a:xfrm>
              <a:off x="6342204" y="1533378"/>
              <a:ext cx="4968221" cy="3957807"/>
              <a:chOff x="6342204" y="1533378"/>
              <a:chExt cx="4968221" cy="3957807"/>
            </a:xfrm>
          </p:grpSpPr>
          <p:sp>
            <p:nvSpPr>
              <p:cNvPr id="8" name="Oval 7"/>
              <p:cNvSpPr/>
              <p:nvPr/>
            </p:nvSpPr>
            <p:spPr>
              <a:xfrm>
                <a:off x="8178084" y="1533378"/>
                <a:ext cx="3132341" cy="3605292"/>
              </a:xfrm>
              <a:prstGeom prst="ellipse">
                <a:avLst/>
              </a:prstGeom>
              <a:solidFill>
                <a:srgbClr val="7030A0">
                  <a:alpha val="1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Oval 8"/>
              <p:cNvSpPr/>
              <p:nvPr/>
            </p:nvSpPr>
            <p:spPr>
              <a:xfrm rot="1774941">
                <a:off x="6342204" y="4012849"/>
                <a:ext cx="3132341" cy="1478336"/>
              </a:xfrm>
              <a:prstGeom prst="ellipse">
                <a:avLst/>
              </a:prstGeom>
              <a:solidFill>
                <a:srgbClr val="33CC33">
                  <a:alpha val="1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" name="Oval 9"/>
              <p:cNvSpPr/>
              <p:nvPr/>
            </p:nvSpPr>
            <p:spPr>
              <a:xfrm rot="1774941">
                <a:off x="8363550" y="4117865"/>
                <a:ext cx="1687507" cy="1196949"/>
              </a:xfrm>
              <a:prstGeom prst="ellipse">
                <a:avLst/>
              </a:prstGeom>
              <a:solidFill>
                <a:srgbClr val="FF0000">
                  <a:alpha val="17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sp>
        <p:nvSpPr>
          <p:cNvPr id="11" name="Rectangle 10"/>
          <p:cNvSpPr/>
          <p:nvPr/>
        </p:nvSpPr>
        <p:spPr>
          <a:xfrm>
            <a:off x="5580226" y="5757832"/>
            <a:ext cx="1782860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>
                <a:solidFill>
                  <a:srgbClr val="7030A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Landraces</a:t>
            </a:r>
          </a:p>
          <a:p>
            <a:r>
              <a:rPr lang="en-US" sz="2000" b="1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mproved lines</a:t>
            </a:r>
          </a:p>
          <a:p>
            <a:r>
              <a:rPr lang="en-GB" sz="2000" b="1" dirty="0">
                <a:solidFill>
                  <a:srgbClr val="33CC33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dvanced</a:t>
            </a:r>
            <a:r>
              <a:rPr lang="en-US" sz="2000" b="1" dirty="0">
                <a:solidFill>
                  <a:srgbClr val="33CC33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lines </a:t>
            </a:r>
            <a:endParaRPr lang="en-GB" sz="2000" b="1" dirty="0">
              <a:solidFill>
                <a:srgbClr val="33CC33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0AE9B9F-EC6F-9B78-7D91-1CA2B306ACE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011" y="1549776"/>
            <a:ext cx="4332991" cy="4366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1266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darnaud</dc:creator>
  <cp:lastModifiedBy>Mahaman Mourtala Issa Zakari</cp:lastModifiedBy>
  <cp:revision>3</cp:revision>
  <dcterms:created xsi:type="dcterms:W3CDTF">2023-01-02T11:38:35Z</dcterms:created>
  <dcterms:modified xsi:type="dcterms:W3CDTF">2024-10-09T18:22:46Z</dcterms:modified>
</cp:coreProperties>
</file>